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49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6327"/>
  </p:normalViewPr>
  <p:slideViewPr>
    <p:cSldViewPr snapToGrid="0" snapToObjects="1" showGuides="1">
      <p:cViewPr varScale="1">
        <p:scale>
          <a:sx n="79" d="100"/>
          <a:sy n="79" d="100"/>
        </p:scale>
        <p:origin x="2970" y="96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4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9F10AC5-BFA8-148F-B788-7910EE4637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7884" t="6822" r="25061" b="6362"/>
          <a:stretch/>
        </p:blipFill>
        <p:spPr>
          <a:xfrm>
            <a:off x="2249388" y="2762126"/>
            <a:ext cx="2456144" cy="1875189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375798B-B3C3-BF61-FAD7-9A6D295694D4}"/>
              </a:ext>
            </a:extLst>
          </p:cNvPr>
          <p:cNvSpPr txBox="1"/>
          <p:nvPr/>
        </p:nvSpPr>
        <p:spPr>
          <a:xfrm>
            <a:off x="2258984" y="4536073"/>
            <a:ext cx="2487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7AD98BD-102D-AC1A-F31A-E083A411E2D9}"/>
              </a:ext>
            </a:extLst>
          </p:cNvPr>
          <p:cNvSpPr txBox="1"/>
          <p:nvPr/>
        </p:nvSpPr>
        <p:spPr>
          <a:xfrm rot="16200000">
            <a:off x="796236" y="3358200"/>
            <a:ext cx="22445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, probabilit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13C697F-3C68-F7C3-6054-8FA45C2DE423}"/>
              </a:ext>
            </a:extLst>
          </p:cNvPr>
          <p:cNvSpPr txBox="1"/>
          <p:nvPr/>
        </p:nvSpPr>
        <p:spPr>
          <a:xfrm>
            <a:off x="3062635" y="4536073"/>
            <a:ext cx="2487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7E89B1B-61EA-E1D3-87F2-588296138407}"/>
              </a:ext>
            </a:extLst>
          </p:cNvPr>
          <p:cNvSpPr txBox="1"/>
          <p:nvPr/>
        </p:nvSpPr>
        <p:spPr>
          <a:xfrm>
            <a:off x="3863730" y="4518304"/>
            <a:ext cx="2487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15E13BD-0B8D-407A-6DD0-1DB63EE34DAE}"/>
              </a:ext>
            </a:extLst>
          </p:cNvPr>
          <p:cNvSpPr txBox="1"/>
          <p:nvPr/>
        </p:nvSpPr>
        <p:spPr>
          <a:xfrm>
            <a:off x="4517543" y="4549720"/>
            <a:ext cx="24878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8A55237-30E8-BD57-2117-25A58357CD24}"/>
              </a:ext>
            </a:extLst>
          </p:cNvPr>
          <p:cNvSpPr txBox="1"/>
          <p:nvPr/>
        </p:nvSpPr>
        <p:spPr>
          <a:xfrm>
            <a:off x="2043066" y="4393484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42A1653-7FA4-02E5-DDD0-AE005DB7F036}"/>
              </a:ext>
            </a:extLst>
          </p:cNvPr>
          <p:cNvSpPr txBox="1"/>
          <p:nvPr/>
        </p:nvSpPr>
        <p:spPr>
          <a:xfrm>
            <a:off x="1973306" y="399058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76625EA-54D9-96D6-28AA-A49E9BED0C80}"/>
              </a:ext>
            </a:extLst>
          </p:cNvPr>
          <p:cNvSpPr txBox="1"/>
          <p:nvPr/>
        </p:nvSpPr>
        <p:spPr>
          <a:xfrm>
            <a:off x="1973306" y="3673705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B19EC1C-ABC3-DB11-8694-C397F3E53798}"/>
              </a:ext>
            </a:extLst>
          </p:cNvPr>
          <p:cNvSpPr txBox="1"/>
          <p:nvPr/>
        </p:nvSpPr>
        <p:spPr>
          <a:xfrm>
            <a:off x="1973306" y="3370470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A724BC7-D83A-E9F5-C6E6-04325A588D0D}"/>
              </a:ext>
            </a:extLst>
          </p:cNvPr>
          <p:cNvSpPr txBox="1"/>
          <p:nvPr/>
        </p:nvSpPr>
        <p:spPr>
          <a:xfrm>
            <a:off x="1973306" y="3044062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EC23EB3-897D-8533-B0D2-8B4128DC5005}"/>
              </a:ext>
            </a:extLst>
          </p:cNvPr>
          <p:cNvSpPr txBox="1"/>
          <p:nvPr/>
        </p:nvSpPr>
        <p:spPr>
          <a:xfrm>
            <a:off x="1973306" y="2764000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E60D0EF-26B6-57B2-B8AD-209263EE4D11}"/>
              </a:ext>
            </a:extLst>
          </p:cNvPr>
          <p:cNvSpPr txBox="1"/>
          <p:nvPr/>
        </p:nvSpPr>
        <p:spPr>
          <a:xfrm>
            <a:off x="3280496" y="484467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611557E-148E-5793-43BE-6D15E7E215AE}"/>
              </a:ext>
            </a:extLst>
          </p:cNvPr>
          <p:cNvSpPr txBox="1"/>
          <p:nvPr/>
        </p:nvSpPr>
        <p:spPr>
          <a:xfrm>
            <a:off x="3835863" y="3198633"/>
            <a:ext cx="118654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-rank p = 0.04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223163FC-AFF0-3B65-FA0C-ECE84EC1241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7619" t="7313" r="5896" b="79868"/>
          <a:stretch/>
        </p:blipFill>
        <p:spPr>
          <a:xfrm>
            <a:off x="4158507" y="2917173"/>
            <a:ext cx="875162" cy="304799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E2BEB92-B751-3540-59A7-C92D3E509456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9931241-ECE5-39ED-668C-F908D80E9361}"/>
              </a:ext>
            </a:extLst>
          </p:cNvPr>
          <p:cNvSpPr txBox="1"/>
          <p:nvPr/>
        </p:nvSpPr>
        <p:spPr>
          <a:xfrm>
            <a:off x="395288" y="5471933"/>
            <a:ext cx="6769099" cy="12803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igure S2. CIN in </a:t>
            </a:r>
            <a:r>
              <a:rPr kumimoji="0" lang="en-US" altLang="ja-JP" sz="1000" b="1" i="1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EGFR</a:t>
            </a:r>
            <a:r>
              <a:rPr kumimoji="0" lang="en-US" altLang="ja-JP" sz="10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-mutated non-small-cell lung cancer is associated with the progression-free survival of patients treated with EGFR-TKIs in another cohort (n = 11).</a:t>
            </a:r>
            <a:r>
              <a:rPr kumimoji="0" lang="en-US" altLang="ja-JP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Progression-free survival curves for patients treated with EGFR-TKIs, separated into CIN-high and CIN-low groups.</a:t>
            </a:r>
            <a:r>
              <a:rPr kumimoji="0" lang="en-US" altLang="ja-JP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IN, chromosomal instability; EGFR-TKI, epidermal growth factor receptor-tyrosine kinase inhibitor.</a:t>
            </a:r>
            <a:endParaRPr kumimoji="0" lang="ja-JP" altLang="ja-JP" sz="10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4391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19</TotalTime>
  <Words>80</Words>
  <Application>Microsoft Office PowerPoint</Application>
  <PresentationFormat>ユーザー設定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28</cp:revision>
  <cp:lastPrinted>2024-06-06T11:43:21Z</cp:lastPrinted>
  <dcterms:created xsi:type="dcterms:W3CDTF">2021-02-12T07:53:00Z</dcterms:created>
  <dcterms:modified xsi:type="dcterms:W3CDTF">2024-08-24T06:13:51Z</dcterms:modified>
</cp:coreProperties>
</file>